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1.xml" ContentType="application/vnd.openxmlformats-officedocument.themeOverr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76" r:id="rId2"/>
    <p:sldId id="274" r:id="rId3"/>
    <p:sldId id="275" r:id="rId4"/>
    <p:sldId id="28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A00"/>
    <a:srgbClr val="0432FF"/>
    <a:srgbClr val="9C5DA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7422" autoAdjust="0"/>
    <p:restoredTop sz="92240" autoAdjust="0"/>
  </p:normalViewPr>
  <p:slideViewPr>
    <p:cSldViewPr snapToGrid="0" snapToObjects="1">
      <p:cViewPr varScale="1">
        <p:scale>
          <a:sx n="89" d="100"/>
          <a:sy n="89" d="100"/>
        </p:scale>
        <p:origin x="90" y="738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ohammad Fereydouni" userId="2680fb214ec0eb88" providerId="LiveId" clId="{88FF8441-BDBC-4EAE-8F50-9EF732BC802E}"/>
    <pc:docChg chg="custSel delSld modSld">
      <pc:chgData name="Mohammad Fereydouni" userId="2680fb214ec0eb88" providerId="LiveId" clId="{88FF8441-BDBC-4EAE-8F50-9EF732BC802E}" dt="2022-02-07T09:36:29.885" v="52" actId="1076"/>
      <pc:docMkLst>
        <pc:docMk/>
      </pc:docMkLst>
      <pc:sldChg chg="del">
        <pc:chgData name="Mohammad Fereydouni" userId="2680fb214ec0eb88" providerId="LiveId" clId="{88FF8441-BDBC-4EAE-8F50-9EF732BC802E}" dt="2022-02-07T09:32:24.452" v="0" actId="47"/>
        <pc:sldMkLst>
          <pc:docMk/>
          <pc:sldMk cId="627168040" sldId="257"/>
        </pc:sldMkLst>
      </pc:sldChg>
      <pc:sldChg chg="del">
        <pc:chgData name="Mohammad Fereydouni" userId="2680fb214ec0eb88" providerId="LiveId" clId="{88FF8441-BDBC-4EAE-8F50-9EF732BC802E}" dt="2022-02-07T09:32:24.452" v="0" actId="47"/>
        <pc:sldMkLst>
          <pc:docMk/>
          <pc:sldMk cId="1179253743" sldId="258"/>
        </pc:sldMkLst>
      </pc:sldChg>
      <pc:sldChg chg="del">
        <pc:chgData name="Mohammad Fereydouni" userId="2680fb214ec0eb88" providerId="LiveId" clId="{88FF8441-BDBC-4EAE-8F50-9EF732BC802E}" dt="2022-02-07T09:32:24.452" v="0" actId="47"/>
        <pc:sldMkLst>
          <pc:docMk/>
          <pc:sldMk cId="106788565" sldId="259"/>
        </pc:sldMkLst>
      </pc:sldChg>
      <pc:sldChg chg="del">
        <pc:chgData name="Mohammad Fereydouni" userId="2680fb214ec0eb88" providerId="LiveId" clId="{88FF8441-BDBC-4EAE-8F50-9EF732BC802E}" dt="2022-02-07T09:32:24.452" v="0" actId="47"/>
        <pc:sldMkLst>
          <pc:docMk/>
          <pc:sldMk cId="1890703261" sldId="260"/>
        </pc:sldMkLst>
      </pc:sldChg>
      <pc:sldChg chg="del">
        <pc:chgData name="Mohammad Fereydouni" userId="2680fb214ec0eb88" providerId="LiveId" clId="{88FF8441-BDBC-4EAE-8F50-9EF732BC802E}" dt="2022-02-07T09:32:24.452" v="0" actId="47"/>
        <pc:sldMkLst>
          <pc:docMk/>
          <pc:sldMk cId="790087709" sldId="262"/>
        </pc:sldMkLst>
      </pc:sldChg>
      <pc:sldChg chg="del">
        <pc:chgData name="Mohammad Fereydouni" userId="2680fb214ec0eb88" providerId="LiveId" clId="{88FF8441-BDBC-4EAE-8F50-9EF732BC802E}" dt="2022-02-07T09:32:24.452" v="0" actId="47"/>
        <pc:sldMkLst>
          <pc:docMk/>
          <pc:sldMk cId="909010032" sldId="267"/>
        </pc:sldMkLst>
      </pc:sldChg>
      <pc:sldChg chg="del">
        <pc:chgData name="Mohammad Fereydouni" userId="2680fb214ec0eb88" providerId="LiveId" clId="{88FF8441-BDBC-4EAE-8F50-9EF732BC802E}" dt="2022-02-07T09:32:24.452" v="0" actId="47"/>
        <pc:sldMkLst>
          <pc:docMk/>
          <pc:sldMk cId="1827540975" sldId="268"/>
        </pc:sldMkLst>
      </pc:sldChg>
      <pc:sldChg chg="del">
        <pc:chgData name="Mohammad Fereydouni" userId="2680fb214ec0eb88" providerId="LiveId" clId="{88FF8441-BDBC-4EAE-8F50-9EF732BC802E}" dt="2022-02-07T09:32:24.452" v="0" actId="47"/>
        <pc:sldMkLst>
          <pc:docMk/>
          <pc:sldMk cId="2688339578" sldId="270"/>
        </pc:sldMkLst>
      </pc:sldChg>
      <pc:sldChg chg="del">
        <pc:chgData name="Mohammad Fereydouni" userId="2680fb214ec0eb88" providerId="LiveId" clId="{88FF8441-BDBC-4EAE-8F50-9EF732BC802E}" dt="2022-02-07T09:32:24.452" v="0" actId="47"/>
        <pc:sldMkLst>
          <pc:docMk/>
          <pc:sldMk cId="1391936091" sldId="271"/>
        </pc:sldMkLst>
      </pc:sldChg>
      <pc:sldChg chg="del">
        <pc:chgData name="Mohammad Fereydouni" userId="2680fb214ec0eb88" providerId="LiveId" clId="{88FF8441-BDBC-4EAE-8F50-9EF732BC802E}" dt="2022-02-07T09:32:24.452" v="0" actId="47"/>
        <pc:sldMkLst>
          <pc:docMk/>
          <pc:sldMk cId="934797422" sldId="273"/>
        </pc:sldMkLst>
      </pc:sldChg>
      <pc:sldChg chg="addSp delSp modSp mod">
        <pc:chgData name="Mohammad Fereydouni" userId="2680fb214ec0eb88" providerId="LiveId" clId="{88FF8441-BDBC-4EAE-8F50-9EF732BC802E}" dt="2022-02-07T09:34:19.113" v="12" actId="14100"/>
        <pc:sldMkLst>
          <pc:docMk/>
          <pc:sldMk cId="158223725" sldId="274"/>
        </pc:sldMkLst>
        <pc:spChg chg="del">
          <ac:chgData name="Mohammad Fereydouni" userId="2680fb214ec0eb88" providerId="LiveId" clId="{88FF8441-BDBC-4EAE-8F50-9EF732BC802E}" dt="2022-02-07T09:33:56.923" v="8" actId="478"/>
          <ac:spMkLst>
            <pc:docMk/>
            <pc:sldMk cId="158223725" sldId="274"/>
            <ac:spMk id="2" creationId="{0557BFDE-B8FB-C34A-90BC-B09CBFE365F1}"/>
          </ac:spMkLst>
        </pc:spChg>
        <pc:spChg chg="add mod">
          <ac:chgData name="Mohammad Fereydouni" userId="2680fb214ec0eb88" providerId="LiveId" clId="{88FF8441-BDBC-4EAE-8F50-9EF732BC802E}" dt="2022-02-07T09:34:19.113" v="12" actId="14100"/>
          <ac:spMkLst>
            <pc:docMk/>
            <pc:sldMk cId="158223725" sldId="274"/>
            <ac:spMk id="14" creationId="{79EBB033-ADA4-4C16-9ABC-AE5A2BA00BB6}"/>
          </ac:spMkLst>
        </pc:spChg>
        <pc:spChg chg="mod">
          <ac:chgData name="Mohammad Fereydouni" userId="2680fb214ec0eb88" providerId="LiveId" clId="{88FF8441-BDBC-4EAE-8F50-9EF732BC802E}" dt="2022-02-07T09:34:01.065" v="9" actId="1076"/>
          <ac:spMkLst>
            <pc:docMk/>
            <pc:sldMk cId="158223725" sldId="274"/>
            <ac:spMk id="31" creationId="{22D84741-C533-411C-ACD0-0DE57CACC115}"/>
          </ac:spMkLst>
        </pc:spChg>
        <pc:spChg chg="mod">
          <ac:chgData name="Mohammad Fereydouni" userId="2680fb214ec0eb88" providerId="LiveId" clId="{88FF8441-BDBC-4EAE-8F50-9EF732BC802E}" dt="2022-02-07T09:34:01.065" v="9" actId="1076"/>
          <ac:spMkLst>
            <pc:docMk/>
            <pc:sldMk cId="158223725" sldId="274"/>
            <ac:spMk id="32" creationId="{22D84741-C533-411C-ACD0-0DE57CACC115}"/>
          </ac:spMkLst>
        </pc:spChg>
        <pc:spChg chg="mod">
          <ac:chgData name="Mohammad Fereydouni" userId="2680fb214ec0eb88" providerId="LiveId" clId="{88FF8441-BDBC-4EAE-8F50-9EF732BC802E}" dt="2022-02-07T09:34:01.065" v="9" actId="1076"/>
          <ac:spMkLst>
            <pc:docMk/>
            <pc:sldMk cId="158223725" sldId="274"/>
            <ac:spMk id="39" creationId="{22D84741-C533-411C-ACD0-0DE57CACC115}"/>
          </ac:spMkLst>
        </pc:spChg>
        <pc:spChg chg="mod">
          <ac:chgData name="Mohammad Fereydouni" userId="2680fb214ec0eb88" providerId="LiveId" clId="{88FF8441-BDBC-4EAE-8F50-9EF732BC802E}" dt="2022-02-07T09:34:01.065" v="9" actId="1076"/>
          <ac:spMkLst>
            <pc:docMk/>
            <pc:sldMk cId="158223725" sldId="274"/>
            <ac:spMk id="41" creationId="{22D84741-C533-411C-ACD0-0DE57CACC115}"/>
          </ac:spMkLst>
        </pc:spChg>
        <pc:spChg chg="mod">
          <ac:chgData name="Mohammad Fereydouni" userId="2680fb214ec0eb88" providerId="LiveId" clId="{88FF8441-BDBC-4EAE-8F50-9EF732BC802E}" dt="2022-02-07T09:34:01.065" v="9" actId="1076"/>
          <ac:spMkLst>
            <pc:docMk/>
            <pc:sldMk cId="158223725" sldId="274"/>
            <ac:spMk id="52" creationId="{1EC2FB2C-85ED-AC47-9796-C9BB94531ED4}"/>
          </ac:spMkLst>
        </pc:spChg>
        <pc:spChg chg="mod">
          <ac:chgData name="Mohammad Fereydouni" userId="2680fb214ec0eb88" providerId="LiveId" clId="{88FF8441-BDBC-4EAE-8F50-9EF732BC802E}" dt="2022-02-07T09:34:01.065" v="9" actId="1076"/>
          <ac:spMkLst>
            <pc:docMk/>
            <pc:sldMk cId="158223725" sldId="274"/>
            <ac:spMk id="53" creationId="{4E08F94C-C917-654E-9510-FBD77FE08397}"/>
          </ac:spMkLst>
        </pc:spChg>
        <pc:picChg chg="mod">
          <ac:chgData name="Mohammad Fereydouni" userId="2680fb214ec0eb88" providerId="LiveId" clId="{88FF8441-BDBC-4EAE-8F50-9EF732BC802E}" dt="2022-02-07T09:34:01.065" v="9" actId="1076"/>
          <ac:picMkLst>
            <pc:docMk/>
            <pc:sldMk cId="158223725" sldId="274"/>
            <ac:picMk id="3" creationId="{00B9EB16-110C-4782-B8DB-C7A157B844FD}"/>
          </ac:picMkLst>
        </pc:picChg>
        <pc:picChg chg="mod">
          <ac:chgData name="Mohammad Fereydouni" userId="2680fb214ec0eb88" providerId="LiveId" clId="{88FF8441-BDBC-4EAE-8F50-9EF732BC802E}" dt="2022-02-07T09:34:01.065" v="9" actId="1076"/>
          <ac:picMkLst>
            <pc:docMk/>
            <pc:sldMk cId="158223725" sldId="274"/>
            <ac:picMk id="7" creationId="{BC51C898-6D5B-473D-BD8A-E8846576255A}"/>
          </ac:picMkLst>
        </pc:picChg>
        <pc:picChg chg="mod">
          <ac:chgData name="Mohammad Fereydouni" userId="2680fb214ec0eb88" providerId="LiveId" clId="{88FF8441-BDBC-4EAE-8F50-9EF732BC802E}" dt="2022-02-07T09:34:01.065" v="9" actId="1076"/>
          <ac:picMkLst>
            <pc:docMk/>
            <pc:sldMk cId="158223725" sldId="274"/>
            <ac:picMk id="9" creationId="{F41A8C03-2F94-4F5E-B39C-E49B8C2D7CAB}"/>
          </ac:picMkLst>
        </pc:picChg>
        <pc:picChg chg="mod">
          <ac:chgData name="Mohammad Fereydouni" userId="2680fb214ec0eb88" providerId="LiveId" clId="{88FF8441-BDBC-4EAE-8F50-9EF732BC802E}" dt="2022-02-07T09:34:01.065" v="9" actId="1076"/>
          <ac:picMkLst>
            <pc:docMk/>
            <pc:sldMk cId="158223725" sldId="274"/>
            <ac:picMk id="13" creationId="{10E0F235-BC87-47ED-ABD1-AF7D837A32A6}"/>
          </ac:picMkLst>
        </pc:picChg>
      </pc:sldChg>
      <pc:sldChg chg="addSp delSp modSp mod">
        <pc:chgData name="Mohammad Fereydouni" userId="2680fb214ec0eb88" providerId="LiveId" clId="{88FF8441-BDBC-4EAE-8F50-9EF732BC802E}" dt="2022-02-07T09:36:00.353" v="44" actId="1076"/>
        <pc:sldMkLst>
          <pc:docMk/>
          <pc:sldMk cId="1965408510" sldId="275"/>
        </pc:sldMkLst>
        <pc:spChg chg="add mod">
          <ac:chgData name="Mohammad Fereydouni" userId="2680fb214ec0eb88" providerId="LiveId" clId="{88FF8441-BDBC-4EAE-8F50-9EF732BC802E}" dt="2022-02-07T09:36:00.353" v="44" actId="1076"/>
          <ac:spMkLst>
            <pc:docMk/>
            <pc:sldMk cId="1965408510" sldId="275"/>
            <ac:spMk id="6" creationId="{136F940A-5DD0-4799-8004-4D4B6714BAAE}"/>
          </ac:spMkLst>
        </pc:spChg>
        <pc:spChg chg="del">
          <ac:chgData name="Mohammad Fereydouni" userId="2680fb214ec0eb88" providerId="LiveId" clId="{88FF8441-BDBC-4EAE-8F50-9EF732BC802E}" dt="2022-02-07T09:35:47.353" v="41" actId="478"/>
          <ac:spMkLst>
            <pc:docMk/>
            <pc:sldMk cId="1965408510" sldId="275"/>
            <ac:spMk id="7" creationId="{2B94127E-8B80-4714-A627-B99403E19E70}"/>
          </ac:spMkLst>
        </pc:spChg>
        <pc:graphicFrameChg chg="mod">
          <ac:chgData name="Mohammad Fereydouni" userId="2680fb214ec0eb88" providerId="LiveId" clId="{88FF8441-BDBC-4EAE-8F50-9EF732BC802E}" dt="2022-02-07T09:35:52.648" v="42" actId="1076"/>
          <ac:graphicFrameMkLst>
            <pc:docMk/>
            <pc:sldMk cId="1965408510" sldId="275"/>
            <ac:graphicFrameMk id="2" creationId="{CECC38D0-5D4E-4429-A783-847F3A546751}"/>
          </ac:graphicFrameMkLst>
        </pc:graphicFrameChg>
        <pc:graphicFrameChg chg="mod">
          <ac:chgData name="Mohammad Fereydouni" userId="2680fb214ec0eb88" providerId="LiveId" clId="{88FF8441-BDBC-4EAE-8F50-9EF732BC802E}" dt="2022-02-07T09:35:52.648" v="42" actId="1076"/>
          <ac:graphicFrameMkLst>
            <pc:docMk/>
            <pc:sldMk cId="1965408510" sldId="275"/>
            <ac:graphicFrameMk id="8" creationId="{66C2BCB7-B67D-4F33-B098-26AADB1B6BAE}"/>
          </ac:graphicFrameMkLst>
        </pc:graphicFrameChg>
      </pc:sldChg>
      <pc:sldChg chg="addSp delSp modSp mod">
        <pc:chgData name="Mohammad Fereydouni" userId="2680fb214ec0eb88" providerId="LiveId" clId="{88FF8441-BDBC-4EAE-8F50-9EF732BC802E}" dt="2022-02-07T09:33:51.993" v="7" actId="1076"/>
        <pc:sldMkLst>
          <pc:docMk/>
          <pc:sldMk cId="2938795516" sldId="276"/>
        </pc:sldMkLst>
        <pc:spChg chg="mod">
          <ac:chgData name="Mohammad Fereydouni" userId="2680fb214ec0eb88" providerId="LiveId" clId="{88FF8441-BDBC-4EAE-8F50-9EF732BC802E}" dt="2022-02-07T09:33:51.993" v="7" actId="1076"/>
          <ac:spMkLst>
            <pc:docMk/>
            <pc:sldMk cId="2938795516" sldId="276"/>
            <ac:spMk id="5" creationId="{E93C219D-FD49-244E-ACA8-45277FB71917}"/>
          </ac:spMkLst>
        </pc:spChg>
        <pc:spChg chg="mod">
          <ac:chgData name="Mohammad Fereydouni" userId="2680fb214ec0eb88" providerId="LiveId" clId="{88FF8441-BDBC-4EAE-8F50-9EF732BC802E}" dt="2022-02-07T09:33:51.993" v="7" actId="1076"/>
          <ac:spMkLst>
            <pc:docMk/>
            <pc:sldMk cId="2938795516" sldId="276"/>
            <ac:spMk id="7" creationId="{269E2FA3-C107-D847-8464-6ED66FD7502F}"/>
          </ac:spMkLst>
        </pc:spChg>
        <pc:spChg chg="mod">
          <ac:chgData name="Mohammad Fereydouni" userId="2680fb214ec0eb88" providerId="LiveId" clId="{88FF8441-BDBC-4EAE-8F50-9EF732BC802E}" dt="2022-02-07T09:33:51.993" v="7" actId="1076"/>
          <ac:spMkLst>
            <pc:docMk/>
            <pc:sldMk cId="2938795516" sldId="276"/>
            <ac:spMk id="8" creationId="{37DAEC4B-BA1A-FC4E-B400-988F481466B5}"/>
          </ac:spMkLst>
        </pc:spChg>
        <pc:spChg chg="mod">
          <ac:chgData name="Mohammad Fereydouni" userId="2680fb214ec0eb88" providerId="LiveId" clId="{88FF8441-BDBC-4EAE-8F50-9EF732BC802E}" dt="2022-02-07T09:33:51.993" v="7" actId="1076"/>
          <ac:spMkLst>
            <pc:docMk/>
            <pc:sldMk cId="2938795516" sldId="276"/>
            <ac:spMk id="9" creationId="{55663DCC-1577-5C43-B8E1-1927BB2101B7}"/>
          </ac:spMkLst>
        </pc:spChg>
        <pc:spChg chg="mod">
          <ac:chgData name="Mohammad Fereydouni" userId="2680fb214ec0eb88" providerId="LiveId" clId="{88FF8441-BDBC-4EAE-8F50-9EF732BC802E}" dt="2022-02-07T09:33:51.993" v="7" actId="1076"/>
          <ac:spMkLst>
            <pc:docMk/>
            <pc:sldMk cId="2938795516" sldId="276"/>
            <ac:spMk id="10" creationId="{24E4654F-2CD7-2D4A-8848-28904803E993}"/>
          </ac:spMkLst>
        </pc:spChg>
        <pc:spChg chg="mod">
          <ac:chgData name="Mohammad Fereydouni" userId="2680fb214ec0eb88" providerId="LiveId" clId="{88FF8441-BDBC-4EAE-8F50-9EF732BC802E}" dt="2022-02-07T09:33:51.993" v="7" actId="1076"/>
          <ac:spMkLst>
            <pc:docMk/>
            <pc:sldMk cId="2938795516" sldId="276"/>
            <ac:spMk id="11" creationId="{0F4A974F-39D0-6649-B268-C808FAB495CC}"/>
          </ac:spMkLst>
        </pc:spChg>
        <pc:spChg chg="del mod">
          <ac:chgData name="Mohammad Fereydouni" userId="2680fb214ec0eb88" providerId="LiveId" clId="{88FF8441-BDBC-4EAE-8F50-9EF732BC802E}" dt="2022-02-07T09:33:46.433" v="6" actId="478"/>
          <ac:spMkLst>
            <pc:docMk/>
            <pc:sldMk cId="2938795516" sldId="276"/>
            <ac:spMk id="12" creationId="{C36A83FC-BE99-2D4D-9B82-EBC589B3CBCF}"/>
          </ac:spMkLst>
        </pc:spChg>
        <pc:spChg chg="add mod">
          <ac:chgData name="Mohammad Fereydouni" userId="2680fb214ec0eb88" providerId="LiveId" clId="{88FF8441-BDBC-4EAE-8F50-9EF732BC802E}" dt="2022-02-07T09:33:51.993" v="7" actId="1076"/>
          <ac:spMkLst>
            <pc:docMk/>
            <pc:sldMk cId="2938795516" sldId="276"/>
            <ac:spMk id="14" creationId="{9A5934A0-D695-4D9B-809B-F4387E196ABB}"/>
          </ac:spMkLst>
        </pc:spChg>
        <pc:picChg chg="mod">
          <ac:chgData name="Mohammad Fereydouni" userId="2680fb214ec0eb88" providerId="LiveId" clId="{88FF8441-BDBC-4EAE-8F50-9EF732BC802E}" dt="2022-02-07T09:33:51.993" v="7" actId="1076"/>
          <ac:picMkLst>
            <pc:docMk/>
            <pc:sldMk cId="2938795516" sldId="276"/>
            <ac:picMk id="2" creationId="{A8F42A81-15A2-6B44-B75C-49F4B9F0D48E}"/>
          </ac:picMkLst>
        </pc:picChg>
        <pc:picChg chg="mod">
          <ac:chgData name="Mohammad Fereydouni" userId="2680fb214ec0eb88" providerId="LiveId" clId="{88FF8441-BDBC-4EAE-8F50-9EF732BC802E}" dt="2022-02-07T09:33:51.993" v="7" actId="1076"/>
          <ac:picMkLst>
            <pc:docMk/>
            <pc:sldMk cId="2938795516" sldId="276"/>
            <ac:picMk id="3" creationId="{1D29D903-3492-344E-B503-3827A0CA3F8B}"/>
          </ac:picMkLst>
        </pc:picChg>
        <pc:picChg chg="mod">
          <ac:chgData name="Mohammad Fereydouni" userId="2680fb214ec0eb88" providerId="LiveId" clId="{88FF8441-BDBC-4EAE-8F50-9EF732BC802E}" dt="2022-02-07T09:33:51.993" v="7" actId="1076"/>
          <ac:picMkLst>
            <pc:docMk/>
            <pc:sldMk cId="2938795516" sldId="276"/>
            <ac:picMk id="4" creationId="{9BE07ECE-B3A1-BA4D-A131-9B44C10B5C24}"/>
          </ac:picMkLst>
        </pc:picChg>
        <pc:picChg chg="mod">
          <ac:chgData name="Mohammad Fereydouni" userId="2680fb214ec0eb88" providerId="LiveId" clId="{88FF8441-BDBC-4EAE-8F50-9EF732BC802E}" dt="2022-02-07T09:33:51.993" v="7" actId="1076"/>
          <ac:picMkLst>
            <pc:docMk/>
            <pc:sldMk cId="2938795516" sldId="276"/>
            <ac:picMk id="6" creationId="{86276DB7-8028-1F43-827F-1EA9BEA2B187}"/>
          </ac:picMkLst>
        </pc:picChg>
      </pc:sldChg>
      <pc:sldChg chg="addSp delSp modSp mod">
        <pc:chgData name="Mohammad Fereydouni" userId="2680fb214ec0eb88" providerId="LiveId" clId="{88FF8441-BDBC-4EAE-8F50-9EF732BC802E}" dt="2022-02-07T09:36:29.885" v="52" actId="1076"/>
        <pc:sldMkLst>
          <pc:docMk/>
          <pc:sldMk cId="4216774625" sldId="280"/>
        </pc:sldMkLst>
        <pc:spChg chg="del">
          <ac:chgData name="Mohammad Fereydouni" userId="2680fb214ec0eb88" providerId="LiveId" clId="{88FF8441-BDBC-4EAE-8F50-9EF732BC802E}" dt="2022-02-07T09:36:04.842" v="45" actId="478"/>
          <ac:spMkLst>
            <pc:docMk/>
            <pc:sldMk cId="4216774625" sldId="280"/>
            <ac:spMk id="2" creationId="{13BF5078-64F3-DA49-8CC2-CEE16386EDBF}"/>
          </ac:spMkLst>
        </pc:spChg>
        <pc:spChg chg="add mod">
          <ac:chgData name="Mohammad Fereydouni" userId="2680fb214ec0eb88" providerId="LiveId" clId="{88FF8441-BDBC-4EAE-8F50-9EF732BC802E}" dt="2022-02-07T09:36:23.974" v="51" actId="1076"/>
          <ac:spMkLst>
            <pc:docMk/>
            <pc:sldMk cId="4216774625" sldId="280"/>
            <ac:spMk id="5" creationId="{C8FA3C2D-3363-4444-B09F-E0D456426973}"/>
          </ac:spMkLst>
        </pc:spChg>
        <pc:graphicFrameChg chg="mod">
          <ac:chgData name="Mohammad Fereydouni" userId="2680fb214ec0eb88" providerId="LiveId" clId="{88FF8441-BDBC-4EAE-8F50-9EF732BC802E}" dt="2022-02-07T09:36:29.885" v="52" actId="1076"/>
          <ac:graphicFrameMkLst>
            <pc:docMk/>
            <pc:sldMk cId="4216774625" sldId="280"/>
            <ac:graphicFrameMk id="10" creationId="{8B1277D4-C953-4042-8F0D-330D4D116CF0}"/>
          </ac:graphicFrameMkLst>
        </pc:graphicFrameChg>
      </pc:sldChg>
    </pc:docChg>
  </pc:docChgLst>
  <pc:docChgLst>
    <pc:chgData name="Mohammad Fereydouni" userId="2680fb214ec0eb88" providerId="LiveId" clId="{569B82DF-7598-4B4C-B894-0BDDDA56E7F8}"/>
    <pc:docChg chg="modSld">
      <pc:chgData name="Mohammad Fereydouni" userId="2680fb214ec0eb88" providerId="LiveId" clId="{569B82DF-7598-4B4C-B894-0BDDDA56E7F8}" dt="2022-02-07T04:55:33.760" v="16" actId="20577"/>
      <pc:docMkLst>
        <pc:docMk/>
      </pc:docMkLst>
      <pc:sldChg chg="modSp mod">
        <pc:chgData name="Mohammad Fereydouni" userId="2680fb214ec0eb88" providerId="LiveId" clId="{569B82DF-7598-4B4C-B894-0BDDDA56E7F8}" dt="2022-02-07T04:55:33.760" v="16" actId="20577"/>
        <pc:sldMkLst>
          <pc:docMk/>
          <pc:sldMk cId="627168040" sldId="257"/>
        </pc:sldMkLst>
        <pc:spChg chg="mod">
          <ac:chgData name="Mohammad Fereydouni" userId="2680fb214ec0eb88" providerId="LiveId" clId="{569B82DF-7598-4B4C-B894-0BDDDA56E7F8}" dt="2022-02-07T04:47:49.377" v="0" actId="1076"/>
          <ac:spMkLst>
            <pc:docMk/>
            <pc:sldMk cId="627168040" sldId="257"/>
            <ac:spMk id="2" creationId="{EE6CA76A-A0BB-8347-A1D3-36DED26181AB}"/>
          </ac:spMkLst>
        </pc:spChg>
        <pc:spChg chg="mod">
          <ac:chgData name="Mohammad Fereydouni" userId="2680fb214ec0eb88" providerId="LiveId" clId="{569B82DF-7598-4B4C-B894-0BDDDA56E7F8}" dt="2022-02-07T04:47:49.377" v="0" actId="1076"/>
          <ac:spMkLst>
            <pc:docMk/>
            <pc:sldMk cId="627168040" sldId="257"/>
            <ac:spMk id="19" creationId="{0E76F89B-1334-AE45-BDD3-F69C2914DF4B}"/>
          </ac:spMkLst>
        </pc:spChg>
        <pc:spChg chg="mod">
          <ac:chgData name="Mohammad Fereydouni" userId="2680fb214ec0eb88" providerId="LiveId" clId="{569B82DF-7598-4B4C-B894-0BDDDA56E7F8}" dt="2022-02-07T04:47:49.377" v="0" actId="1076"/>
          <ac:spMkLst>
            <pc:docMk/>
            <pc:sldMk cId="627168040" sldId="257"/>
            <ac:spMk id="20" creationId="{CA980E78-871F-4F41-966E-8400DB880A2F}"/>
          </ac:spMkLst>
        </pc:spChg>
        <pc:spChg chg="mod">
          <ac:chgData name="Mohammad Fereydouni" userId="2680fb214ec0eb88" providerId="LiveId" clId="{569B82DF-7598-4B4C-B894-0BDDDA56E7F8}" dt="2022-02-07T04:47:49.377" v="0" actId="1076"/>
          <ac:spMkLst>
            <pc:docMk/>
            <pc:sldMk cId="627168040" sldId="257"/>
            <ac:spMk id="21" creationId="{7B97B049-935F-644C-8740-2A56BACC4A48}"/>
          </ac:spMkLst>
        </pc:spChg>
        <pc:spChg chg="mod">
          <ac:chgData name="Mohammad Fereydouni" userId="2680fb214ec0eb88" providerId="LiveId" clId="{569B82DF-7598-4B4C-B894-0BDDDA56E7F8}" dt="2022-02-07T04:47:49.377" v="0" actId="1076"/>
          <ac:spMkLst>
            <pc:docMk/>
            <pc:sldMk cId="627168040" sldId="257"/>
            <ac:spMk id="22" creationId="{45C7D1D8-E2CF-3B49-89E3-4EF90D0E5F2D}"/>
          </ac:spMkLst>
        </pc:spChg>
        <pc:spChg chg="mod">
          <ac:chgData name="Mohammad Fereydouni" userId="2680fb214ec0eb88" providerId="LiveId" clId="{569B82DF-7598-4B4C-B894-0BDDDA56E7F8}" dt="2022-02-07T04:47:49.377" v="0" actId="1076"/>
          <ac:spMkLst>
            <pc:docMk/>
            <pc:sldMk cId="627168040" sldId="257"/>
            <ac:spMk id="23" creationId="{E3A0E4BF-6DD8-5540-9BBA-37CA7109EAB3}"/>
          </ac:spMkLst>
        </pc:spChg>
        <pc:spChg chg="mod">
          <ac:chgData name="Mohammad Fereydouni" userId="2680fb214ec0eb88" providerId="LiveId" clId="{569B82DF-7598-4B4C-B894-0BDDDA56E7F8}" dt="2022-02-07T04:55:23.280" v="14" actId="20577"/>
          <ac:spMkLst>
            <pc:docMk/>
            <pc:sldMk cId="627168040" sldId="257"/>
            <ac:spMk id="26" creationId="{2BAB1814-7FD4-404C-AD42-2A214AC2C3B1}"/>
          </ac:spMkLst>
        </pc:spChg>
        <pc:spChg chg="mod">
          <ac:chgData name="Mohammad Fereydouni" userId="2680fb214ec0eb88" providerId="LiveId" clId="{569B82DF-7598-4B4C-B894-0BDDDA56E7F8}" dt="2022-02-07T04:55:33.760" v="16" actId="20577"/>
          <ac:spMkLst>
            <pc:docMk/>
            <pc:sldMk cId="627168040" sldId="257"/>
            <ac:spMk id="27" creationId="{2A04BAB3-7A8A-CF45-A30D-1F44F4C65369}"/>
          </ac:spMkLst>
        </pc:spChg>
        <pc:spChg chg="mod">
          <ac:chgData name="Mohammad Fereydouni" userId="2680fb214ec0eb88" providerId="LiveId" clId="{569B82DF-7598-4B4C-B894-0BDDDA56E7F8}" dt="2022-02-07T04:47:49.377" v="0" actId="1076"/>
          <ac:spMkLst>
            <pc:docMk/>
            <pc:sldMk cId="627168040" sldId="257"/>
            <ac:spMk id="28" creationId="{00000000-0000-0000-0000-000000000000}"/>
          </ac:spMkLst>
        </pc:spChg>
        <pc:spChg chg="mod">
          <ac:chgData name="Mohammad Fereydouni" userId="2680fb214ec0eb88" providerId="LiveId" clId="{569B82DF-7598-4B4C-B894-0BDDDA56E7F8}" dt="2022-02-07T04:47:49.377" v="0" actId="1076"/>
          <ac:spMkLst>
            <pc:docMk/>
            <pc:sldMk cId="627168040" sldId="257"/>
            <ac:spMk id="29" creationId="{4C18E553-3F8B-2647-9F41-171A131D63F7}"/>
          </ac:spMkLst>
        </pc:spChg>
        <pc:spChg chg="mod">
          <ac:chgData name="Mohammad Fereydouni" userId="2680fb214ec0eb88" providerId="LiveId" clId="{569B82DF-7598-4B4C-B894-0BDDDA56E7F8}" dt="2022-02-07T04:47:49.377" v="0" actId="1076"/>
          <ac:spMkLst>
            <pc:docMk/>
            <pc:sldMk cId="627168040" sldId="257"/>
            <ac:spMk id="30" creationId="{FF2C53F5-4F80-F941-B712-95B36D348190}"/>
          </ac:spMkLst>
        </pc:spChg>
        <pc:spChg chg="mod">
          <ac:chgData name="Mohammad Fereydouni" userId="2680fb214ec0eb88" providerId="LiveId" clId="{569B82DF-7598-4B4C-B894-0BDDDA56E7F8}" dt="2022-02-07T04:47:49.377" v="0" actId="1076"/>
          <ac:spMkLst>
            <pc:docMk/>
            <pc:sldMk cId="627168040" sldId="257"/>
            <ac:spMk id="33" creationId="{126E458C-3000-B547-8B09-B0FB1AE0488E}"/>
          </ac:spMkLst>
        </pc:spChg>
        <pc:spChg chg="mod">
          <ac:chgData name="Mohammad Fereydouni" userId="2680fb214ec0eb88" providerId="LiveId" clId="{569B82DF-7598-4B4C-B894-0BDDDA56E7F8}" dt="2022-02-07T04:47:49.377" v="0" actId="1076"/>
          <ac:spMkLst>
            <pc:docMk/>
            <pc:sldMk cId="627168040" sldId="257"/>
            <ac:spMk id="34" creationId="{F7A3CDD1-02D8-4948-9C8B-557267574613}"/>
          </ac:spMkLst>
        </pc:spChg>
        <pc:spChg chg="mod">
          <ac:chgData name="Mohammad Fereydouni" userId="2680fb214ec0eb88" providerId="LiveId" clId="{569B82DF-7598-4B4C-B894-0BDDDA56E7F8}" dt="2022-02-07T04:47:49.377" v="0" actId="1076"/>
          <ac:spMkLst>
            <pc:docMk/>
            <pc:sldMk cId="627168040" sldId="257"/>
            <ac:spMk id="35" creationId="{42ACB2B3-C247-3242-95F8-0E9196138D45}"/>
          </ac:spMkLst>
        </pc:spChg>
        <pc:spChg chg="mod">
          <ac:chgData name="Mohammad Fereydouni" userId="2680fb214ec0eb88" providerId="LiveId" clId="{569B82DF-7598-4B4C-B894-0BDDDA56E7F8}" dt="2022-02-07T04:47:49.377" v="0" actId="1076"/>
          <ac:spMkLst>
            <pc:docMk/>
            <pc:sldMk cId="627168040" sldId="257"/>
            <ac:spMk id="36" creationId="{00000000-0000-0000-0000-000000000000}"/>
          </ac:spMkLst>
        </pc:spChg>
        <pc:spChg chg="mod">
          <ac:chgData name="Mohammad Fereydouni" userId="2680fb214ec0eb88" providerId="LiveId" clId="{569B82DF-7598-4B4C-B894-0BDDDA56E7F8}" dt="2022-02-07T04:47:49.377" v="0" actId="1076"/>
          <ac:spMkLst>
            <pc:docMk/>
            <pc:sldMk cId="627168040" sldId="257"/>
            <ac:spMk id="38" creationId="{00000000-0000-0000-0000-000000000000}"/>
          </ac:spMkLst>
        </pc:spChg>
        <pc:spChg chg="mod">
          <ac:chgData name="Mohammad Fereydouni" userId="2680fb214ec0eb88" providerId="LiveId" clId="{569B82DF-7598-4B4C-B894-0BDDDA56E7F8}" dt="2022-02-07T04:47:49.377" v="0" actId="1076"/>
          <ac:spMkLst>
            <pc:docMk/>
            <pc:sldMk cId="627168040" sldId="257"/>
            <ac:spMk id="39" creationId="{00000000-0000-0000-0000-000000000000}"/>
          </ac:spMkLst>
        </pc:spChg>
        <pc:spChg chg="mod">
          <ac:chgData name="Mohammad Fereydouni" userId="2680fb214ec0eb88" providerId="LiveId" clId="{569B82DF-7598-4B4C-B894-0BDDDA56E7F8}" dt="2022-02-07T04:47:49.377" v="0" actId="1076"/>
          <ac:spMkLst>
            <pc:docMk/>
            <pc:sldMk cId="627168040" sldId="257"/>
            <ac:spMk id="40" creationId="{00000000-0000-0000-0000-000000000000}"/>
          </ac:spMkLst>
        </pc:spChg>
        <pc:spChg chg="mod">
          <ac:chgData name="Mohammad Fereydouni" userId="2680fb214ec0eb88" providerId="LiveId" clId="{569B82DF-7598-4B4C-B894-0BDDDA56E7F8}" dt="2022-02-07T04:47:49.377" v="0" actId="1076"/>
          <ac:spMkLst>
            <pc:docMk/>
            <pc:sldMk cId="627168040" sldId="257"/>
            <ac:spMk id="42" creationId="{D3D1189A-E7BF-6943-9F39-CCF2C50E4B3B}"/>
          </ac:spMkLst>
        </pc:spChg>
        <pc:spChg chg="mod">
          <ac:chgData name="Mohammad Fereydouni" userId="2680fb214ec0eb88" providerId="LiveId" clId="{569B82DF-7598-4B4C-B894-0BDDDA56E7F8}" dt="2022-02-07T04:47:49.377" v="0" actId="1076"/>
          <ac:spMkLst>
            <pc:docMk/>
            <pc:sldMk cId="627168040" sldId="257"/>
            <ac:spMk id="43" creationId="{F36ED3F7-C1C3-F642-9DB0-C62A14A4BE35}"/>
          </ac:spMkLst>
        </pc:spChg>
        <pc:spChg chg="mod">
          <ac:chgData name="Mohammad Fereydouni" userId="2680fb214ec0eb88" providerId="LiveId" clId="{569B82DF-7598-4B4C-B894-0BDDDA56E7F8}" dt="2022-02-07T04:47:49.377" v="0" actId="1076"/>
          <ac:spMkLst>
            <pc:docMk/>
            <pc:sldMk cId="627168040" sldId="257"/>
            <ac:spMk id="44" creationId="{77346B24-6C68-FD46-AC4E-7688056C3B3D}"/>
          </ac:spMkLst>
        </pc:spChg>
        <pc:spChg chg="mod">
          <ac:chgData name="Mohammad Fereydouni" userId="2680fb214ec0eb88" providerId="LiveId" clId="{569B82DF-7598-4B4C-B894-0BDDDA56E7F8}" dt="2022-02-07T04:47:49.377" v="0" actId="1076"/>
          <ac:spMkLst>
            <pc:docMk/>
            <pc:sldMk cId="627168040" sldId="257"/>
            <ac:spMk id="47" creationId="{A804E12D-5B37-9C44-9AF0-EB77927322AD}"/>
          </ac:spMkLst>
        </pc:spChg>
        <pc:spChg chg="mod">
          <ac:chgData name="Mohammad Fereydouni" userId="2680fb214ec0eb88" providerId="LiveId" clId="{569B82DF-7598-4B4C-B894-0BDDDA56E7F8}" dt="2022-02-07T04:47:49.377" v="0" actId="1076"/>
          <ac:spMkLst>
            <pc:docMk/>
            <pc:sldMk cId="627168040" sldId="257"/>
            <ac:spMk id="56" creationId="{00000000-0000-0000-0000-000000000000}"/>
          </ac:spMkLst>
        </pc:spChg>
        <pc:spChg chg="mod">
          <ac:chgData name="Mohammad Fereydouni" userId="2680fb214ec0eb88" providerId="LiveId" clId="{569B82DF-7598-4B4C-B894-0BDDDA56E7F8}" dt="2022-02-07T04:47:49.377" v="0" actId="1076"/>
          <ac:spMkLst>
            <pc:docMk/>
            <pc:sldMk cId="627168040" sldId="257"/>
            <ac:spMk id="57" creationId="{00000000-0000-0000-0000-000000000000}"/>
          </ac:spMkLst>
        </pc:spChg>
        <pc:graphicFrameChg chg="mod">
          <ac:chgData name="Mohammad Fereydouni" userId="2680fb214ec0eb88" providerId="LiveId" clId="{569B82DF-7598-4B4C-B894-0BDDDA56E7F8}" dt="2022-02-07T04:47:49.377" v="0" actId="1076"/>
          <ac:graphicFrameMkLst>
            <pc:docMk/>
            <pc:sldMk cId="627168040" sldId="257"/>
            <ac:graphicFrameMk id="31" creationId="{00000000-0008-0000-0700-000017000000}"/>
          </ac:graphicFrameMkLst>
        </pc:graphicFrameChg>
        <pc:graphicFrameChg chg="mod">
          <ac:chgData name="Mohammad Fereydouni" userId="2680fb214ec0eb88" providerId="LiveId" clId="{569B82DF-7598-4B4C-B894-0BDDDA56E7F8}" dt="2022-02-07T04:47:49.377" v="0" actId="1076"/>
          <ac:graphicFrameMkLst>
            <pc:docMk/>
            <pc:sldMk cId="627168040" sldId="257"/>
            <ac:graphicFrameMk id="37" creationId="{00000000-0008-0000-0600-000003000000}"/>
          </ac:graphicFrameMkLst>
        </pc:graphicFrameChg>
        <pc:picChg chg="mod">
          <ac:chgData name="Mohammad Fereydouni" userId="2680fb214ec0eb88" providerId="LiveId" clId="{569B82DF-7598-4B4C-B894-0BDDDA56E7F8}" dt="2022-02-07T04:47:49.377" v="0" actId="1076"/>
          <ac:picMkLst>
            <pc:docMk/>
            <pc:sldMk cId="627168040" sldId="257"/>
            <ac:picMk id="16" creationId="{4315CC66-7F5E-FB4E-B447-92670DF139D4}"/>
          </ac:picMkLst>
        </pc:picChg>
        <pc:picChg chg="mod">
          <ac:chgData name="Mohammad Fereydouni" userId="2680fb214ec0eb88" providerId="LiveId" clId="{569B82DF-7598-4B4C-B894-0BDDDA56E7F8}" dt="2022-02-07T04:47:49.377" v="0" actId="1076"/>
          <ac:picMkLst>
            <pc:docMk/>
            <pc:sldMk cId="627168040" sldId="257"/>
            <ac:picMk id="17" creationId="{72973AF3-389C-6644-92F9-529E1DE828A1}"/>
          </ac:picMkLst>
        </pc:picChg>
        <pc:cxnChg chg="mod">
          <ac:chgData name="Mohammad Fereydouni" userId="2680fb214ec0eb88" providerId="LiveId" clId="{569B82DF-7598-4B4C-B894-0BDDDA56E7F8}" dt="2022-02-07T04:47:49.377" v="0" actId="1076"/>
          <ac:cxnSpMkLst>
            <pc:docMk/>
            <pc:sldMk cId="627168040" sldId="257"/>
            <ac:cxnSpMk id="4" creationId="{DAD43CAC-7ED5-6448-B0C6-3F59621DE184}"/>
          </ac:cxnSpMkLst>
        </pc:cxnChg>
        <pc:cxnChg chg="mod">
          <ac:chgData name="Mohammad Fereydouni" userId="2680fb214ec0eb88" providerId="LiveId" clId="{569B82DF-7598-4B4C-B894-0BDDDA56E7F8}" dt="2022-02-07T04:47:49.377" v="0" actId="1076"/>
          <ac:cxnSpMkLst>
            <pc:docMk/>
            <pc:sldMk cId="627168040" sldId="257"/>
            <ac:cxnSpMk id="32" creationId="{05AEB129-7992-EA4C-9F33-00B86741158D}"/>
          </ac:cxnSpMkLst>
        </pc:cxnChg>
        <pc:cxnChg chg="mod">
          <ac:chgData name="Mohammad Fereydouni" userId="2680fb214ec0eb88" providerId="LiveId" clId="{569B82DF-7598-4B4C-B894-0BDDDA56E7F8}" dt="2022-02-07T04:47:49.377" v="0" actId="1076"/>
          <ac:cxnSpMkLst>
            <pc:docMk/>
            <pc:sldMk cId="627168040" sldId="257"/>
            <ac:cxnSpMk id="41" creationId="{7F2C59D2-4511-7140-BAF4-DD78887D5823}"/>
          </ac:cxnSpMkLst>
        </pc:cxnChg>
        <pc:cxnChg chg="mod">
          <ac:chgData name="Mohammad Fereydouni" userId="2680fb214ec0eb88" providerId="LiveId" clId="{569B82DF-7598-4B4C-B894-0BDDDA56E7F8}" dt="2022-02-07T04:47:49.377" v="0" actId="1076"/>
          <ac:cxnSpMkLst>
            <pc:docMk/>
            <pc:sldMk cId="627168040" sldId="257"/>
            <ac:cxnSpMk id="45" creationId="{9DA9BF70-DDD9-9445-9527-726E15A045BB}"/>
          </ac:cxnSpMkLst>
        </pc:cxnChg>
      </pc:sldChg>
      <pc:sldChg chg="modSp mod">
        <pc:chgData name="Mohammad Fereydouni" userId="2680fb214ec0eb88" providerId="LiveId" clId="{569B82DF-7598-4B4C-B894-0BDDDA56E7F8}" dt="2022-02-07T04:55:14.758" v="12" actId="20577"/>
        <pc:sldMkLst>
          <pc:docMk/>
          <pc:sldMk cId="1179253743" sldId="258"/>
        </pc:sldMkLst>
        <pc:spChg chg="mod">
          <ac:chgData name="Mohammad Fereydouni" userId="2680fb214ec0eb88" providerId="LiveId" clId="{569B82DF-7598-4B4C-B894-0BDDDA56E7F8}" dt="2022-02-07T04:55:09.338" v="10" actId="20577"/>
          <ac:spMkLst>
            <pc:docMk/>
            <pc:sldMk cId="1179253743" sldId="258"/>
            <ac:spMk id="5" creationId="{00000000-0000-0000-0000-000000000000}"/>
          </ac:spMkLst>
        </pc:spChg>
        <pc:spChg chg="mod">
          <ac:chgData name="Mohammad Fereydouni" userId="2680fb214ec0eb88" providerId="LiveId" clId="{569B82DF-7598-4B4C-B894-0BDDDA56E7F8}" dt="2022-02-07T04:55:14.758" v="12" actId="20577"/>
          <ac:spMkLst>
            <pc:docMk/>
            <pc:sldMk cId="1179253743" sldId="258"/>
            <ac:spMk id="92" creationId="{00000000-0000-0000-0000-000000000000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_fereyd\Downloads\in%20vivo\Manuscript\New%20Microsoft%20Excel%20Workshee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2">
                <a:lumMod val="50000"/>
              </a:schemeClr>
            </a:solidFill>
            <a:ln>
              <a:solidFill>
                <a:schemeClr val="bg2">
                  <a:lumMod val="50000"/>
                </a:schemeClr>
              </a:solidFill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invertIfNegative val="0"/>
          <c:cat>
            <c:strRef>
              <c:f>(Sheet1!$G$21,Sheet1!$G$24)</c:f>
              <c:strCache>
                <c:ptCount val="2"/>
                <c:pt idx="0">
                  <c:v>BT474 Control</c:v>
                </c:pt>
                <c:pt idx="1">
                  <c:v>BT474+ICLV1261</c:v>
                </c:pt>
              </c:strCache>
            </c:strRef>
          </c:cat>
          <c:val>
            <c:numRef>
              <c:f>(Sheet1!$F$21,Sheet1!$F$24)</c:f>
              <c:numCache>
                <c:formatCode>General</c:formatCode>
                <c:ptCount val="2"/>
                <c:pt idx="0">
                  <c:v>1.2575984750746774E-2</c:v>
                </c:pt>
                <c:pt idx="1">
                  <c:v>3.54472877132451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97F-4B58-A77F-80E0F57C93B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575557144"/>
        <c:axId val="575558128"/>
      </c:barChart>
      <c:catAx>
        <c:axId val="5755571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75558128"/>
        <c:crosses val="autoZero"/>
        <c:auto val="1"/>
        <c:lblAlgn val="ctr"/>
        <c:lblOffset val="100"/>
        <c:noMultiLvlLbl val="0"/>
      </c:catAx>
      <c:valAx>
        <c:axId val="5755581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LU/µg (x1,000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755571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315757543039735"/>
          <c:y val="0.17033223411176165"/>
          <c:w val="0.858718641845162"/>
          <c:h val="0.7069674103237095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c:spPr>
          <c:invertIfNegative val="0"/>
          <c:errBars>
            <c:errBarType val="both"/>
            <c:errValType val="fixedVal"/>
            <c:noEndCap val="0"/>
            <c:val val="5"/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calculatuons Tryptase'!$N$3:$N$6</c:f>
              <c:strCache>
                <c:ptCount val="4"/>
                <c:pt idx="0">
                  <c:v>Transfection Reagent</c:v>
                </c:pt>
                <c:pt idx="1">
                  <c:v>5</c:v>
                </c:pt>
                <c:pt idx="2">
                  <c:v>10</c:v>
                </c:pt>
                <c:pt idx="3">
                  <c:v>20</c:v>
                </c:pt>
              </c:strCache>
            </c:strRef>
          </c:cat>
          <c:val>
            <c:numRef>
              <c:f>'calculatuons Tryptase'!$O$3:$O$6</c:f>
              <c:numCache>
                <c:formatCode>General</c:formatCode>
                <c:ptCount val="4"/>
                <c:pt idx="0">
                  <c:v>16.497418961534837</c:v>
                </c:pt>
                <c:pt idx="1">
                  <c:v>62.365768317370986</c:v>
                </c:pt>
                <c:pt idx="2">
                  <c:v>75.463898239727897</c:v>
                </c:pt>
                <c:pt idx="3">
                  <c:v>92.9477874495651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CEA-7343-B3C5-5ECC3680E13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25847152"/>
        <c:axId val="625850432"/>
      </c:barChart>
      <c:catAx>
        <c:axId val="62584715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 b="1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                   siRNA</a:t>
                </a:r>
                <a:r>
                  <a:rPr lang="en-US" sz="900" b="1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oncentration picomoles</a:t>
                </a:r>
                <a:endParaRPr lang="en-US" sz="900" b="1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25850432"/>
        <c:crosses val="autoZero"/>
        <c:auto val="1"/>
        <c:lblAlgn val="ctr"/>
        <c:lblOffset val="100"/>
        <c:noMultiLvlLbl val="0"/>
      </c:catAx>
      <c:valAx>
        <c:axId val="625850432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50000"/>
                  <a:lumOff val="50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 b="1" u="none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  <a:r>
                  <a:rPr lang="en-US" sz="900" b="1" u="none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ryptase inhibition</a:t>
                </a:r>
                <a:endParaRPr lang="en-US" sz="900" b="1" u="none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258471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lt1"/>
    </cs:fontRef>
  </cs:dataPoint>
  <cs:dataPoint3D>
    <cs:lnRef idx="0"/>
    <cs:fillRef idx="3">
      <cs:styleClr val="auto"/>
    </cs:fillRef>
    <cs:effectRef idx="3"/>
    <cs:fontRef idx="minor">
      <a:schemeClr val="lt1"/>
    </cs:fontRef>
  </cs:dataPoint3D>
  <cs:dataPointLine>
    <cs:lnRef idx="0">
      <cs:styleClr val="auto"/>
    </cs:lnRef>
    <cs:fillRef idx="3"/>
    <cs:effectRef idx="3"/>
    <cs:fontRef idx="minor">
      <a:schemeClr val="lt1"/>
    </cs:fontRef>
    <cs:spPr>
      <a:ln w="349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lt1"/>
    </cs:fontRef>
    <cs:spPr>
      <a:ln w="952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lt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lt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C0FED0-4D6A-8148-93B2-855823FA1045}" type="datetimeFigureOut">
              <a:rPr lang="en-US" smtClean="0"/>
              <a:t>2/7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E3CE2D-099B-9F41-861D-9D781A32E4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73488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79B7CDD-674E-1347-8C73-D923D26F1C0F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92971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A4394-9A3A-224B-965A-EBBA861A45FA}" type="datetimeFigureOut">
              <a:rPr lang="en-US" smtClean="0"/>
              <a:t>2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A2829-CA2A-D645-ABD7-BAA784CEE6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72890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A4394-9A3A-224B-965A-EBBA861A45FA}" type="datetimeFigureOut">
              <a:rPr lang="en-US" smtClean="0"/>
              <a:t>2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A2829-CA2A-D645-ABD7-BAA784CEE6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4493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A4394-9A3A-224B-965A-EBBA861A45FA}" type="datetimeFigureOut">
              <a:rPr lang="en-US" smtClean="0"/>
              <a:t>2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A2829-CA2A-D645-ABD7-BAA784CEE6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63385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A4394-9A3A-224B-965A-EBBA861A45FA}" type="datetimeFigureOut">
              <a:rPr lang="en-US" smtClean="0"/>
              <a:t>2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A2829-CA2A-D645-ABD7-BAA784CEE6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616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A4394-9A3A-224B-965A-EBBA861A45FA}" type="datetimeFigureOut">
              <a:rPr lang="en-US" smtClean="0"/>
              <a:t>2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A2829-CA2A-D645-ABD7-BAA784CEE6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419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A4394-9A3A-224B-965A-EBBA861A45FA}" type="datetimeFigureOut">
              <a:rPr lang="en-US" smtClean="0"/>
              <a:t>2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A2829-CA2A-D645-ABD7-BAA784CEE6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24593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A4394-9A3A-224B-965A-EBBA861A45FA}" type="datetimeFigureOut">
              <a:rPr lang="en-US" smtClean="0"/>
              <a:t>2/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A2829-CA2A-D645-ABD7-BAA784CEE6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0937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A4394-9A3A-224B-965A-EBBA861A45FA}" type="datetimeFigureOut">
              <a:rPr lang="en-US" smtClean="0"/>
              <a:t>2/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A2829-CA2A-D645-ABD7-BAA784CEE6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795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A4394-9A3A-224B-965A-EBBA861A45FA}" type="datetimeFigureOut">
              <a:rPr lang="en-US" smtClean="0"/>
              <a:t>2/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A2829-CA2A-D645-ABD7-BAA784CEE6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56846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A4394-9A3A-224B-965A-EBBA861A45FA}" type="datetimeFigureOut">
              <a:rPr lang="en-US" smtClean="0"/>
              <a:t>2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A2829-CA2A-D645-ABD7-BAA784CEE6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70972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A4394-9A3A-224B-965A-EBBA861A45FA}" type="datetimeFigureOut">
              <a:rPr lang="en-US" smtClean="0"/>
              <a:t>2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A2829-CA2A-D645-ABD7-BAA784CEE6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02528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CA4394-9A3A-224B-965A-EBBA861A45FA}" type="datetimeFigureOut">
              <a:rPr lang="en-US" smtClean="0"/>
              <a:t>2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2A2829-CA2A-D645-ABD7-BAA784CEE6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942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jpg"/><Relationship Id="rId5" Type="http://schemas.openxmlformats.org/officeDocument/2006/relationships/image" Target="../media/image7.jpg"/><Relationship Id="rId4" Type="http://schemas.openxmlformats.org/officeDocument/2006/relationships/image" Target="../media/image6.jp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8F42A81-15A2-6B44-B75C-49F4B9F0D48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39092" y="679901"/>
            <a:ext cx="2914783" cy="219467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1D29D903-3492-344E-B503-3827A0CA3F8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5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39092" y="2935949"/>
            <a:ext cx="2914729" cy="219467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9BE07ECE-B3A1-BA4D-A131-9B44C10B5C2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24000"/>
                    </a14:imgEffect>
                    <a14:imgEffect>
                      <a14:brightnessContrast bright="37000" contrast="1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86519" y="2938962"/>
            <a:ext cx="2914783" cy="219467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93C219D-FD49-244E-ACA8-45277FB71917}"/>
              </a:ext>
            </a:extLst>
          </p:cNvPr>
          <p:cNvSpPr txBox="1"/>
          <p:nvPr/>
        </p:nvSpPr>
        <p:spPr>
          <a:xfrm>
            <a:off x="6420419" y="679901"/>
            <a:ext cx="769886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R2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u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gE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86276DB7-8028-1F43-827F-1EA9BEA2B18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8810" y="682914"/>
            <a:ext cx="2914783" cy="219467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269E2FA3-C107-D847-8464-6ED66FD7502F}"/>
              </a:ext>
            </a:extLst>
          </p:cNvPr>
          <p:cNvSpPr txBox="1"/>
          <p:nvPr/>
        </p:nvSpPr>
        <p:spPr>
          <a:xfrm>
            <a:off x="3129742" y="682914"/>
            <a:ext cx="325276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>
                <a:latin typeface="Times New Roman" panose="02020603050405020304" pitchFamily="18" charset="0"/>
                <a:cs typeface="Times New Roman" panose="02020603050405020304" pitchFamily="18" charset="0"/>
              </a:rPr>
              <a:t>psIgE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7DAEC4B-BA1A-FC4E-B400-988F481466B5}"/>
              </a:ext>
            </a:extLst>
          </p:cNvPr>
          <p:cNvSpPr txBox="1"/>
          <p:nvPr/>
        </p:nvSpPr>
        <p:spPr>
          <a:xfrm>
            <a:off x="6772256" y="2649575"/>
            <a:ext cx="420408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000 µM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5663DCC-1577-5C43-B8E1-1927BB2101B7}"/>
              </a:ext>
            </a:extLst>
          </p:cNvPr>
          <p:cNvSpPr txBox="1"/>
          <p:nvPr/>
        </p:nvSpPr>
        <p:spPr>
          <a:xfrm>
            <a:off x="3511195" y="2652588"/>
            <a:ext cx="420408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000 µM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4E4654F-2CD7-2D4A-8848-28904803E993}"/>
              </a:ext>
            </a:extLst>
          </p:cNvPr>
          <p:cNvSpPr txBox="1"/>
          <p:nvPr/>
        </p:nvSpPr>
        <p:spPr>
          <a:xfrm>
            <a:off x="6772256" y="4895874"/>
            <a:ext cx="355094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800">
                <a:latin typeface="Times New Roman" panose="02020603050405020304" pitchFamily="18" charset="0"/>
                <a:cs typeface="Times New Roman" panose="02020603050405020304" pitchFamily="18" charset="0"/>
              </a:rPr>
              <a:t>400 µM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F4A974F-39D0-6649-B268-C808FAB495CC}"/>
              </a:ext>
            </a:extLst>
          </p:cNvPr>
          <p:cNvSpPr txBox="1"/>
          <p:nvPr/>
        </p:nvSpPr>
        <p:spPr>
          <a:xfrm>
            <a:off x="3599404" y="4898887"/>
            <a:ext cx="355094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800">
                <a:latin typeface="Times New Roman" panose="02020603050405020304" pitchFamily="18" charset="0"/>
                <a:cs typeface="Times New Roman" panose="02020603050405020304" pitchFamily="18" charset="0"/>
              </a:rPr>
              <a:t>400 µM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A5934A0-D695-4D9B-809B-F4387E196ABB}"/>
              </a:ext>
            </a:extLst>
          </p:cNvPr>
          <p:cNvSpPr txBox="1"/>
          <p:nvPr/>
        </p:nvSpPr>
        <p:spPr>
          <a:xfrm>
            <a:off x="1693778" y="5291806"/>
            <a:ext cx="9453282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600"/>
              </a:spcBef>
              <a:spcAft>
                <a:spcPts val="120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1.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umor sections from HER2/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eu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gE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sensitized ADMC challenged animals were incubated with apoptosis-detecting Caspase 3/7 dye, washed, and visualized using fluorescent microscopy.  Apoptotic cells can be observed in tumors from HER2/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eu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ut not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sIgE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umors.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US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387955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0B9EB16-110C-4782-B8DB-C7A157B844F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67803" y="2472968"/>
            <a:ext cx="2227884" cy="1670913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C51C898-6D5B-473D-BD8A-E8846576255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43889" y="2472968"/>
            <a:ext cx="2227886" cy="1670914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F41A8C03-2F94-4F5E-B39C-E49B8C2D7CA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4289" y="752174"/>
            <a:ext cx="2227884" cy="1670913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10E0F235-BC87-47ED-ABD1-AF7D837A32A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0375" y="752174"/>
            <a:ext cx="2227886" cy="1670914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22D84741-C533-411C-ACD0-0DE57CACC115}"/>
              </a:ext>
            </a:extLst>
          </p:cNvPr>
          <p:cNvSpPr txBox="1"/>
          <p:nvPr/>
        </p:nvSpPr>
        <p:spPr>
          <a:xfrm>
            <a:off x="5719093" y="3959215"/>
            <a:ext cx="228788" cy="184666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x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2D84741-C533-411C-ACD0-0DE57CACC115}"/>
              </a:ext>
            </a:extLst>
          </p:cNvPr>
          <p:cNvSpPr txBox="1"/>
          <p:nvPr/>
        </p:nvSpPr>
        <p:spPr>
          <a:xfrm>
            <a:off x="8034221" y="3959215"/>
            <a:ext cx="237554" cy="184666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x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22D84741-C533-411C-ACD0-0DE57CACC115}"/>
              </a:ext>
            </a:extLst>
          </p:cNvPr>
          <p:cNvSpPr txBox="1"/>
          <p:nvPr/>
        </p:nvSpPr>
        <p:spPr>
          <a:xfrm>
            <a:off x="3774288" y="761726"/>
            <a:ext cx="46521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PC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2D84741-C533-411C-ACD0-0DE57CACC115}"/>
              </a:ext>
            </a:extLst>
          </p:cNvPr>
          <p:cNvSpPr txBox="1"/>
          <p:nvPr/>
        </p:nvSpPr>
        <p:spPr>
          <a:xfrm>
            <a:off x="3774552" y="2488869"/>
            <a:ext cx="464946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yptase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1EC2FB2C-85ED-AC47-9796-C9BB94531ED4}"/>
              </a:ext>
            </a:extLst>
          </p:cNvPr>
          <p:cNvSpPr txBox="1"/>
          <p:nvPr/>
        </p:nvSpPr>
        <p:spPr>
          <a:xfrm>
            <a:off x="5766899" y="2238421"/>
            <a:ext cx="228788" cy="184666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x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E08F94C-C917-654E-9510-FBD77FE08397}"/>
              </a:ext>
            </a:extLst>
          </p:cNvPr>
          <p:cNvSpPr txBox="1"/>
          <p:nvPr/>
        </p:nvSpPr>
        <p:spPr>
          <a:xfrm>
            <a:off x="8034221" y="2238421"/>
            <a:ext cx="237554" cy="184666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x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9EBB033-ADA4-4C16-9ABC-AE5A2BA00BB6}"/>
              </a:ext>
            </a:extLst>
          </p:cNvPr>
          <p:cNvSpPr txBox="1"/>
          <p:nvPr/>
        </p:nvSpPr>
        <p:spPr>
          <a:xfrm>
            <a:off x="1841128" y="4605705"/>
            <a:ext cx="895955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600"/>
              </a:spcBef>
              <a:spcAft>
                <a:spcPts val="120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2.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mmunohistochemistry of ADMC distribution in tumor tissues.  Tumor sections from HER2/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eu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gE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sensitized ADMC challenged animals were incubated with isotype control (MOPC) or anti-human tryptase (G3) Abs and visualized as above.</a:t>
            </a:r>
            <a:endParaRPr lang="en-US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2237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66C2BCB7-B67D-4F33-B098-26AADB1B6BA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48794166"/>
              </p:ext>
            </p:extLst>
          </p:nvPr>
        </p:nvGraphicFramePr>
        <p:xfrm>
          <a:off x="3900487" y="685800"/>
          <a:ext cx="408622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CECC38D0-5D4E-4429-A783-847F3A54675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73385863"/>
              </p:ext>
            </p:extLst>
          </p:nvPr>
        </p:nvGraphicFramePr>
        <p:xfrm>
          <a:off x="4051300" y="3676304"/>
          <a:ext cx="4089400" cy="1362075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256325">
                  <a:extLst>
                    <a:ext uri="{9D8B030D-6E8A-4147-A177-3AD203B41FA5}">
                      <a16:colId xmlns:a16="http://schemas.microsoft.com/office/drawing/2014/main" val="3113934792"/>
                    </a:ext>
                  </a:extLst>
                </a:gridCol>
                <a:gridCol w="609127">
                  <a:extLst>
                    <a:ext uri="{9D8B030D-6E8A-4147-A177-3AD203B41FA5}">
                      <a16:colId xmlns:a16="http://schemas.microsoft.com/office/drawing/2014/main" val="3346280955"/>
                    </a:ext>
                  </a:extLst>
                </a:gridCol>
                <a:gridCol w="710648">
                  <a:extLst>
                    <a:ext uri="{9D8B030D-6E8A-4147-A177-3AD203B41FA5}">
                      <a16:colId xmlns:a16="http://schemas.microsoft.com/office/drawing/2014/main" val="1220385038"/>
                    </a:ext>
                  </a:extLst>
                </a:gridCol>
                <a:gridCol w="713821">
                  <a:extLst>
                    <a:ext uri="{9D8B030D-6E8A-4147-A177-3AD203B41FA5}">
                      <a16:colId xmlns:a16="http://schemas.microsoft.com/office/drawing/2014/main" val="2639421923"/>
                    </a:ext>
                  </a:extLst>
                </a:gridCol>
                <a:gridCol w="799479">
                  <a:extLst>
                    <a:ext uri="{9D8B030D-6E8A-4147-A177-3AD203B41FA5}">
                      <a16:colId xmlns:a16="http://schemas.microsoft.com/office/drawing/2014/main" val="2490028252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LU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ein ug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LU/ug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975628135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T474 Contro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0.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.67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185026187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36365333"/>
                  </a:ext>
                </a:extLst>
              </a:tr>
              <a:tr h="20002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54055218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T474+ICLV1261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075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3,285.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.7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544.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11271040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564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3969789"/>
                  </a:ext>
                </a:extLst>
              </a:tr>
              <a:tr h="20002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345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02041338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136F940A-5DD0-4799-8004-4D4B6714BAAE}"/>
              </a:ext>
            </a:extLst>
          </p:cNvPr>
          <p:cNvSpPr txBox="1"/>
          <p:nvPr/>
        </p:nvSpPr>
        <p:spPr>
          <a:xfrm>
            <a:off x="2283310" y="5419514"/>
            <a:ext cx="833448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600"/>
              </a:spcBef>
              <a:spcAft>
                <a:spcPts val="120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3.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ransduction of BT-474 cells with Firefly luciferase and Green Fluorescent Protein (GFP). </a:t>
            </a:r>
            <a:endParaRPr lang="en-US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654085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8B1277D4-C953-4042-8F0D-330D4D116CF0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94520185"/>
              </p:ext>
            </p:extLst>
          </p:nvPr>
        </p:nvGraphicFramePr>
        <p:xfrm>
          <a:off x="3942397" y="991736"/>
          <a:ext cx="4307205" cy="28439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C8FA3C2D-3363-4444-B09F-E0D456426973}"/>
              </a:ext>
            </a:extLst>
          </p:cNvPr>
          <p:cNvSpPr txBox="1"/>
          <p:nvPr/>
        </p:nvSpPr>
        <p:spPr>
          <a:xfrm>
            <a:off x="1422698" y="4444268"/>
            <a:ext cx="9150144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600"/>
              </a:spcBef>
              <a:spcAft>
                <a:spcPts val="120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4.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he inhibition of tryptase (a) and knockdown of tryptase using siRNA to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PSAB1.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Cs (2 × 10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were incubated with three different concentrations of Silencer® Select Pre-designed siRNA in AIM-V media for 72 h. Transfection reagent was used as a negative control for this experiment. Cells were washed, RNAs extracted, and qPCR performed using primers to amplify short fragments of the β-actin and tryptase mRNA. In parallel, cells with tryptase inhibition were used for the confocal experiments in Figure 7.  </a:t>
            </a:r>
            <a:endParaRPr lang="en-US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67746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45483</TotalTime>
  <Words>261</Words>
  <Application>Microsoft Office PowerPoint</Application>
  <PresentationFormat>Widescreen</PresentationFormat>
  <Paragraphs>39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opher Kepley</dc:creator>
  <cp:lastModifiedBy>Mohammad Fereydouni</cp:lastModifiedBy>
  <cp:revision>333</cp:revision>
  <cp:lastPrinted>2021-11-30T14:55:38Z</cp:lastPrinted>
  <dcterms:created xsi:type="dcterms:W3CDTF">2021-02-01T15:08:32Z</dcterms:created>
  <dcterms:modified xsi:type="dcterms:W3CDTF">2022-02-07T09:36:34Z</dcterms:modified>
</cp:coreProperties>
</file>